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7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97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A6219C-28D0-7FBB-5F06-0A9FA35B10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AFF4D9-C2BF-A1AE-91F1-40237A560B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E40D5C-099C-A3C2-4E8D-6B8CE08EB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F2293D-F9A4-042F-8223-3C9457FDC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603260-2860-30BD-2E8E-4C6690DF1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83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082DD-1B6D-41D0-40B4-F7B5AC5D8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226772-620D-5115-D623-A3E615C59D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48A1F5-4F45-AC6D-8D6E-DC8F31E87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90CB9-1DA3-D68E-4262-0445A82BB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81609-D629-8719-0887-B2AF2A721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5538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247798-4B69-6992-454C-CA4B228CD2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E066E5-2365-0276-2481-029E455876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00B6FB-83FC-AFB9-49A1-6F25E6D2D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BD5E8A-7FBF-B1F2-F8ED-652A970EE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5DEA46-FA99-ABA9-5459-3C098DB5C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950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C94545-5B7E-F08F-6BE1-EC897FBDF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A5C344-980A-009E-8790-D692EDFAA0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82EE9B-9678-61F6-6762-519400710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6D13E5-9144-8935-5BD5-6C23A061C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186974-FC15-EDE6-F027-499B21D61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462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B63D4-708B-744E-D8CF-16AA9424B6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5727F4-42B6-4835-BB0F-A6CF9022E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BA927-7252-905E-6539-4384AD5F1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B8B71-864B-90BF-A237-EDDAB8DFC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694A25-EB25-69D9-8D34-88A90BEEA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4041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89E09-F188-C3F2-2D07-AFDC7FF94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55E71F-6176-6510-71E7-5CC7BCF551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A2AE7E-DF53-2F3F-1642-84C6CE462B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A33882-C063-338B-D02A-3C5E99130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B70AD6-2A6A-E91F-7013-9026A84D7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D2A0A1-0D2F-DD37-E804-F2C93B8FD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2694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17DD43-ACF4-E0BF-EAC6-B66AEB413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129C15-1026-D96F-5A1C-D32E1E0374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89C397-935E-6223-A80F-C2EB0B37DF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EF8A7D-B43E-7BFF-1EDE-6209D09DF1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83D2A2-64A2-20DE-7241-2F56BC22F0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597D6B-E29A-9784-8181-A0E38D6C2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2483F-A6FB-BF8B-6F44-51D59DDE9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36BB3D-E719-7DD9-53A4-19389A581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56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B7B7C-864B-2B6C-7D12-39C6EC145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B3F36B-C5B2-126F-E955-C2D33309D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2AB72F-ACFD-5261-11E8-C73F9E5E2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8FF429-8470-26DF-1E22-D6D1AC029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3915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A041A6-9E92-9D25-6C71-4224A6A5C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C44AE3-7EFC-CA14-E62C-D4EDE3E5B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321406-4AAC-E446-853F-501CA8DD8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8788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78274-C6C3-041E-AA75-95EA4DE6F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3BB9D1-CADD-A742-2DB6-CBF78C5B41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9E64A8-1310-5315-7903-1362EFE66A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BA840E-6850-A3F7-D105-CBE513C5C0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A76949-D9D2-085D-5CD8-12C647312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962DBB-B051-A759-EE1C-405D67505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38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8490A-0287-3A0C-366F-95E9790CA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1F8AC2-BF34-DB6B-8340-D9C7BF59DC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72564C-365F-AE9C-8E1D-1A6A245C64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A1D1D7-5CC5-B5E7-4DC9-8AC5264ED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69B8DA-3F59-19E0-D3E0-5A32F30D3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36430E-CAC2-F891-8E7C-7F33B0A0D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799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B2867D-D19E-9959-13B1-692DFE5B5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811ED2-5C3A-9662-62D5-9EAFD61126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5B2104-DF6C-0372-0199-37605C26CF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3FD516-0836-4CAA-9D5B-A6C2B9C8044A}" type="datetimeFigureOut">
              <a:rPr lang="en-GB" smtClean="0"/>
              <a:t>0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FFA202-3DD9-A530-40F3-6EB77AFDAE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66C4AF-6A13-57C2-334D-9E98B95227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5257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50">
            <a:extLst>
              <a:ext uri="{FF2B5EF4-FFF2-40B4-BE49-F238E27FC236}">
                <a16:creationId xmlns:a16="http://schemas.microsoft.com/office/drawing/2014/main" id="{01E12BEF-20E6-D21F-09BA-3AFD70590B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1342022" y="4285987"/>
            <a:ext cx="7340723" cy="128644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3F848BD-1821-273A-3AF4-CAFE67E8DE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8947" y="1282469"/>
            <a:ext cx="7811994" cy="298099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E593738-1F37-637D-FD72-742C5ECEA10B}"/>
              </a:ext>
            </a:extLst>
          </p:cNvPr>
          <p:cNvSpPr txBox="1"/>
          <p:nvPr/>
        </p:nvSpPr>
        <p:spPr>
          <a:xfrm>
            <a:off x="385747" y="162673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05FFDC-E3DA-4B98-8449-60CE3CD10BEE}"/>
              </a:ext>
            </a:extLst>
          </p:cNvPr>
          <p:cNvSpPr txBox="1"/>
          <p:nvPr/>
        </p:nvSpPr>
        <p:spPr>
          <a:xfrm>
            <a:off x="403066" y="195694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C99AE6-B447-C576-5DDB-ECDEB2982084}"/>
              </a:ext>
            </a:extLst>
          </p:cNvPr>
          <p:cNvSpPr txBox="1"/>
          <p:nvPr/>
        </p:nvSpPr>
        <p:spPr>
          <a:xfrm>
            <a:off x="403066" y="230125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39BA74-F694-3FAC-B838-70F46B775606}"/>
              </a:ext>
            </a:extLst>
          </p:cNvPr>
          <p:cNvSpPr txBox="1"/>
          <p:nvPr/>
        </p:nvSpPr>
        <p:spPr>
          <a:xfrm>
            <a:off x="403066" y="262919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060396-99A5-1180-022A-3905FE728683}"/>
              </a:ext>
            </a:extLst>
          </p:cNvPr>
          <p:cNvSpPr txBox="1"/>
          <p:nvPr/>
        </p:nvSpPr>
        <p:spPr>
          <a:xfrm>
            <a:off x="385747" y="302180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D17AA5-36DF-3412-7F1B-04394051AFAA}"/>
              </a:ext>
            </a:extLst>
          </p:cNvPr>
          <p:cNvSpPr txBox="1"/>
          <p:nvPr/>
        </p:nvSpPr>
        <p:spPr>
          <a:xfrm>
            <a:off x="460188" y="344675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D49D82-7EF9-47B7-ABCA-ABFE34594AB4}"/>
              </a:ext>
            </a:extLst>
          </p:cNvPr>
          <p:cNvSpPr txBox="1"/>
          <p:nvPr/>
        </p:nvSpPr>
        <p:spPr>
          <a:xfrm>
            <a:off x="7353792" y="104403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415DF8C-E9A6-5C99-AD8E-3D6DD471D8EB}"/>
              </a:ext>
            </a:extLst>
          </p:cNvPr>
          <p:cNvSpPr txBox="1"/>
          <p:nvPr/>
        </p:nvSpPr>
        <p:spPr>
          <a:xfrm>
            <a:off x="6837598" y="104403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C311E4-C9F2-0D4E-BFD1-7DF0C4C4C345}"/>
              </a:ext>
            </a:extLst>
          </p:cNvPr>
          <p:cNvSpPr txBox="1"/>
          <p:nvPr/>
        </p:nvSpPr>
        <p:spPr>
          <a:xfrm>
            <a:off x="4987534" y="1055105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A41F3C-B527-63FF-732D-0C314C2347E9}"/>
              </a:ext>
            </a:extLst>
          </p:cNvPr>
          <p:cNvSpPr txBox="1"/>
          <p:nvPr/>
        </p:nvSpPr>
        <p:spPr>
          <a:xfrm>
            <a:off x="4555704" y="104403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4E9BBE-597C-74C2-C399-3096F56051DC}"/>
              </a:ext>
            </a:extLst>
          </p:cNvPr>
          <p:cNvSpPr txBox="1"/>
          <p:nvPr/>
        </p:nvSpPr>
        <p:spPr>
          <a:xfrm>
            <a:off x="2830069" y="1009634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7117649-BE49-8591-9260-86EA556E4507}"/>
              </a:ext>
            </a:extLst>
          </p:cNvPr>
          <p:cNvSpPr txBox="1"/>
          <p:nvPr/>
        </p:nvSpPr>
        <p:spPr>
          <a:xfrm>
            <a:off x="2372393" y="100963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FEF37DF-3896-012F-71B4-9BC71C019F42}"/>
              </a:ext>
            </a:extLst>
          </p:cNvPr>
          <p:cNvSpPr txBox="1"/>
          <p:nvPr/>
        </p:nvSpPr>
        <p:spPr>
          <a:xfrm>
            <a:off x="2699264" y="592054"/>
            <a:ext cx="441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C81EDDA-9AF0-8ABE-5879-A15F6A09AC57}"/>
              </a:ext>
            </a:extLst>
          </p:cNvPr>
          <p:cNvSpPr txBox="1"/>
          <p:nvPr/>
        </p:nvSpPr>
        <p:spPr>
          <a:xfrm>
            <a:off x="1610134" y="640302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8FD0432-3040-8696-BD67-1D8528751A89}"/>
              </a:ext>
            </a:extLst>
          </p:cNvPr>
          <p:cNvCxnSpPr>
            <a:cxnSpLocks/>
          </p:cNvCxnSpPr>
          <p:nvPr/>
        </p:nvCxnSpPr>
        <p:spPr>
          <a:xfrm>
            <a:off x="2471612" y="961386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3D38347-8CD2-62C0-2923-2567C0A1156D}"/>
              </a:ext>
            </a:extLst>
          </p:cNvPr>
          <p:cNvSpPr txBox="1"/>
          <p:nvPr/>
        </p:nvSpPr>
        <p:spPr>
          <a:xfrm>
            <a:off x="4766961" y="57915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5AC9354-24FF-9A91-0E57-5B1F8740D786}"/>
              </a:ext>
            </a:extLst>
          </p:cNvPr>
          <p:cNvCxnSpPr/>
          <p:nvPr/>
        </p:nvCxnSpPr>
        <p:spPr>
          <a:xfrm>
            <a:off x="4539309" y="948486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98E8EFFC-FC81-7755-1888-82B0A342974A}"/>
              </a:ext>
            </a:extLst>
          </p:cNvPr>
          <p:cNvSpPr txBox="1"/>
          <p:nvPr/>
        </p:nvSpPr>
        <p:spPr>
          <a:xfrm>
            <a:off x="7143881" y="59917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FF04BBF-CA1C-0902-0205-9D98C48F2FF1}"/>
              </a:ext>
            </a:extLst>
          </p:cNvPr>
          <p:cNvCxnSpPr/>
          <p:nvPr/>
        </p:nvCxnSpPr>
        <p:spPr>
          <a:xfrm>
            <a:off x="6916229" y="968511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A52C39A-18FF-E8F8-58E7-568542917E89}"/>
              </a:ext>
            </a:extLst>
          </p:cNvPr>
          <p:cNvSpPr txBox="1"/>
          <p:nvPr/>
        </p:nvSpPr>
        <p:spPr>
          <a:xfrm>
            <a:off x="278237" y="192961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DA46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BC7BCDB-F89F-D1DB-6A11-EAF927C904E2}"/>
              </a:ext>
            </a:extLst>
          </p:cNvPr>
          <p:cNvSpPr txBox="1"/>
          <p:nvPr/>
        </p:nvSpPr>
        <p:spPr>
          <a:xfrm>
            <a:off x="286994" y="4306227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972427-BA57-FFB8-59F8-8142280D9D2A}"/>
              </a:ext>
            </a:extLst>
          </p:cNvPr>
          <p:cNvSpPr txBox="1"/>
          <p:nvPr/>
        </p:nvSpPr>
        <p:spPr>
          <a:xfrm>
            <a:off x="286994" y="4537053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FB9C15D-0613-A2BF-764D-B018C893C91D}"/>
              </a:ext>
            </a:extLst>
          </p:cNvPr>
          <p:cNvSpPr txBox="1"/>
          <p:nvPr/>
        </p:nvSpPr>
        <p:spPr>
          <a:xfrm>
            <a:off x="286994" y="4925953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3FA4C72-7A8D-A3A1-41FC-AA7753491844}"/>
              </a:ext>
            </a:extLst>
          </p:cNvPr>
          <p:cNvSpPr txBox="1"/>
          <p:nvPr/>
        </p:nvSpPr>
        <p:spPr>
          <a:xfrm>
            <a:off x="8436809" y="2445995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3106455-9A2C-7AE9-0123-E0C23E51F022}"/>
              </a:ext>
            </a:extLst>
          </p:cNvPr>
          <p:cNvSpPr txBox="1"/>
          <p:nvPr/>
        </p:nvSpPr>
        <p:spPr>
          <a:xfrm>
            <a:off x="8360143" y="4744543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DD1118DA-4B91-B25F-9E65-28539805C0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1309557" y="4350341"/>
            <a:ext cx="519047" cy="922071"/>
          </a:xfrm>
          <a:prstGeom prst="rect">
            <a:avLst/>
          </a:prstGeom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EA09D891-1ABD-8400-F07C-BEEADE4EEA62}"/>
              </a:ext>
            </a:extLst>
          </p:cNvPr>
          <p:cNvSpPr/>
          <p:nvPr/>
        </p:nvSpPr>
        <p:spPr>
          <a:xfrm>
            <a:off x="2395308" y="2233117"/>
            <a:ext cx="1004644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B911649E-91D4-3EB8-90A0-06CA9E781315}"/>
              </a:ext>
            </a:extLst>
          </p:cNvPr>
          <p:cNvSpPr/>
          <p:nvPr/>
        </p:nvSpPr>
        <p:spPr>
          <a:xfrm>
            <a:off x="2348066" y="4685719"/>
            <a:ext cx="1268893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8718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6">
            <a:extLst>
              <a:ext uri="{FF2B5EF4-FFF2-40B4-BE49-F238E27FC236}">
                <a16:creationId xmlns:a16="http://schemas.microsoft.com/office/drawing/2014/main" id="{42F1D25C-02D2-99B0-6E8F-5D6D442C1D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5588" y="1069841"/>
            <a:ext cx="8848725" cy="43624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E593738-1F37-637D-FD72-742C5ECEA10B}"/>
              </a:ext>
            </a:extLst>
          </p:cNvPr>
          <p:cNvSpPr txBox="1"/>
          <p:nvPr/>
        </p:nvSpPr>
        <p:spPr>
          <a:xfrm>
            <a:off x="9169520" y="1677597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05FFDC-E3DA-4B98-8449-60CE3CD10BEE}"/>
              </a:ext>
            </a:extLst>
          </p:cNvPr>
          <p:cNvSpPr txBox="1"/>
          <p:nvPr/>
        </p:nvSpPr>
        <p:spPr>
          <a:xfrm>
            <a:off x="9169520" y="213451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C99AE6-B447-C576-5DDB-ECDEB2982084}"/>
              </a:ext>
            </a:extLst>
          </p:cNvPr>
          <p:cNvSpPr txBox="1"/>
          <p:nvPr/>
        </p:nvSpPr>
        <p:spPr>
          <a:xfrm>
            <a:off x="9169520" y="271599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39BA74-F694-3FAC-B838-70F46B775606}"/>
              </a:ext>
            </a:extLst>
          </p:cNvPr>
          <p:cNvSpPr txBox="1"/>
          <p:nvPr/>
        </p:nvSpPr>
        <p:spPr>
          <a:xfrm>
            <a:off x="9169519" y="315928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060396-99A5-1180-022A-3905FE728683}"/>
              </a:ext>
            </a:extLst>
          </p:cNvPr>
          <p:cNvSpPr txBox="1"/>
          <p:nvPr/>
        </p:nvSpPr>
        <p:spPr>
          <a:xfrm>
            <a:off x="9169519" y="385907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D17AA5-36DF-3412-7F1B-04394051AFAA}"/>
              </a:ext>
            </a:extLst>
          </p:cNvPr>
          <p:cNvSpPr txBox="1"/>
          <p:nvPr/>
        </p:nvSpPr>
        <p:spPr>
          <a:xfrm>
            <a:off x="9169518" y="467795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D49D82-7EF9-47B7-ABCA-ABFE34594AB4}"/>
              </a:ext>
            </a:extLst>
          </p:cNvPr>
          <p:cNvSpPr txBox="1"/>
          <p:nvPr/>
        </p:nvSpPr>
        <p:spPr>
          <a:xfrm>
            <a:off x="8181377" y="104403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B33889D-7AD6-0767-6635-45DEBFF5E2B1}"/>
              </a:ext>
            </a:extLst>
          </p:cNvPr>
          <p:cNvSpPr txBox="1"/>
          <p:nvPr/>
        </p:nvSpPr>
        <p:spPr>
          <a:xfrm>
            <a:off x="6579614" y="104403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415DF8C-E9A6-5C99-AD8E-3D6DD471D8EB}"/>
              </a:ext>
            </a:extLst>
          </p:cNvPr>
          <p:cNvSpPr txBox="1"/>
          <p:nvPr/>
        </p:nvSpPr>
        <p:spPr>
          <a:xfrm>
            <a:off x="7665183" y="104403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7492B1-257E-6B68-493C-E3DC1F93D20A}"/>
              </a:ext>
            </a:extLst>
          </p:cNvPr>
          <p:cNvSpPr txBox="1"/>
          <p:nvPr/>
        </p:nvSpPr>
        <p:spPr>
          <a:xfrm>
            <a:off x="7185576" y="104403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D905A8-FD24-2ECE-F2DC-E9E3773CC032}"/>
              </a:ext>
            </a:extLst>
          </p:cNvPr>
          <p:cNvSpPr txBox="1"/>
          <p:nvPr/>
        </p:nvSpPr>
        <p:spPr>
          <a:xfrm>
            <a:off x="5494045" y="104403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224D152-568C-CFC6-B644-24ACA04429D2}"/>
              </a:ext>
            </a:extLst>
          </p:cNvPr>
          <p:cNvSpPr txBox="1"/>
          <p:nvPr/>
        </p:nvSpPr>
        <p:spPr>
          <a:xfrm>
            <a:off x="6100007" y="104403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C311E4-C9F2-0D4E-BFD1-7DF0C4C4C345}"/>
              </a:ext>
            </a:extLst>
          </p:cNvPr>
          <p:cNvSpPr txBox="1"/>
          <p:nvPr/>
        </p:nvSpPr>
        <p:spPr>
          <a:xfrm>
            <a:off x="3949742" y="104403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A41F3C-B527-63FF-732D-0C314C2347E9}"/>
              </a:ext>
            </a:extLst>
          </p:cNvPr>
          <p:cNvSpPr txBox="1"/>
          <p:nvPr/>
        </p:nvSpPr>
        <p:spPr>
          <a:xfrm>
            <a:off x="4555704" y="104403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4E9BBE-597C-74C2-C399-3096F56051DC}"/>
              </a:ext>
            </a:extLst>
          </p:cNvPr>
          <p:cNvSpPr txBox="1"/>
          <p:nvPr/>
        </p:nvSpPr>
        <p:spPr>
          <a:xfrm>
            <a:off x="2830069" y="1009634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CC2AC6-3F73-7E42-942A-6D3BDDE6526B}"/>
              </a:ext>
            </a:extLst>
          </p:cNvPr>
          <p:cNvSpPr txBox="1"/>
          <p:nvPr/>
        </p:nvSpPr>
        <p:spPr>
          <a:xfrm>
            <a:off x="3436031" y="100963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486D19F-05A6-7544-9449-7C05D32E7C15}"/>
              </a:ext>
            </a:extLst>
          </p:cNvPr>
          <p:cNvSpPr txBox="1"/>
          <p:nvPr/>
        </p:nvSpPr>
        <p:spPr>
          <a:xfrm>
            <a:off x="1766431" y="1009634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7117649-BE49-8591-9260-86EA556E4507}"/>
              </a:ext>
            </a:extLst>
          </p:cNvPr>
          <p:cNvSpPr txBox="1"/>
          <p:nvPr/>
        </p:nvSpPr>
        <p:spPr>
          <a:xfrm>
            <a:off x="2372393" y="100963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FEF37DF-3896-012F-71B4-9BC71C019F42}"/>
              </a:ext>
            </a:extLst>
          </p:cNvPr>
          <p:cNvSpPr txBox="1"/>
          <p:nvPr/>
        </p:nvSpPr>
        <p:spPr>
          <a:xfrm>
            <a:off x="2076772" y="51155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C81EDDA-9AF0-8ABE-5879-A15F6A09AC57}"/>
              </a:ext>
            </a:extLst>
          </p:cNvPr>
          <p:cNvSpPr txBox="1"/>
          <p:nvPr/>
        </p:nvSpPr>
        <p:spPr>
          <a:xfrm>
            <a:off x="1209868" y="416307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8FD0432-3040-8696-BD67-1D8528751A89}"/>
              </a:ext>
            </a:extLst>
          </p:cNvPr>
          <p:cNvCxnSpPr/>
          <p:nvPr/>
        </p:nvCxnSpPr>
        <p:spPr>
          <a:xfrm>
            <a:off x="1849120" y="880885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3D38347-8CD2-62C0-2923-2567C0A1156D}"/>
              </a:ext>
            </a:extLst>
          </p:cNvPr>
          <p:cNvSpPr txBox="1"/>
          <p:nvPr/>
        </p:nvSpPr>
        <p:spPr>
          <a:xfrm>
            <a:off x="3064029" y="51155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5AC9354-24FF-9A91-0E57-5B1F8740D786}"/>
              </a:ext>
            </a:extLst>
          </p:cNvPr>
          <p:cNvCxnSpPr/>
          <p:nvPr/>
        </p:nvCxnSpPr>
        <p:spPr>
          <a:xfrm>
            <a:off x="2836377" y="880885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34E435E-C616-3705-C6C5-26D1895D0F28}"/>
              </a:ext>
            </a:extLst>
          </p:cNvPr>
          <p:cNvSpPr txBox="1"/>
          <p:nvPr/>
        </p:nvSpPr>
        <p:spPr>
          <a:xfrm>
            <a:off x="4287056" y="51892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1A0B9E8-A075-4443-594E-DA0EB0BB1747}"/>
              </a:ext>
            </a:extLst>
          </p:cNvPr>
          <p:cNvCxnSpPr/>
          <p:nvPr/>
        </p:nvCxnSpPr>
        <p:spPr>
          <a:xfrm>
            <a:off x="4059404" y="888255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C00859E6-E215-2B8A-C92F-5929E9D102FC}"/>
              </a:ext>
            </a:extLst>
          </p:cNvPr>
          <p:cNvSpPr txBox="1"/>
          <p:nvPr/>
        </p:nvSpPr>
        <p:spPr>
          <a:xfrm>
            <a:off x="5820424" y="50110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C4DB8EAD-93B3-32C8-17D5-538AD1324CF6}"/>
              </a:ext>
            </a:extLst>
          </p:cNvPr>
          <p:cNvCxnSpPr/>
          <p:nvPr/>
        </p:nvCxnSpPr>
        <p:spPr>
          <a:xfrm>
            <a:off x="5592772" y="870438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A31DA9A9-BE39-F495-577A-2720F031D8BD}"/>
              </a:ext>
            </a:extLst>
          </p:cNvPr>
          <p:cNvSpPr txBox="1"/>
          <p:nvPr/>
        </p:nvSpPr>
        <p:spPr>
          <a:xfrm>
            <a:off x="6912646" y="48575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6D97AD7-6E18-2861-78AF-2992CD7D57B7}"/>
              </a:ext>
            </a:extLst>
          </p:cNvPr>
          <p:cNvCxnSpPr/>
          <p:nvPr/>
        </p:nvCxnSpPr>
        <p:spPr>
          <a:xfrm>
            <a:off x="6684994" y="855082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98E8EFFC-FC81-7755-1888-82B0A342974A}"/>
              </a:ext>
            </a:extLst>
          </p:cNvPr>
          <p:cNvSpPr txBox="1"/>
          <p:nvPr/>
        </p:nvSpPr>
        <p:spPr>
          <a:xfrm>
            <a:off x="8020065" y="48513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FF04BBF-CA1C-0902-0205-9D98C48F2FF1}"/>
              </a:ext>
            </a:extLst>
          </p:cNvPr>
          <p:cNvCxnSpPr/>
          <p:nvPr/>
        </p:nvCxnSpPr>
        <p:spPr>
          <a:xfrm>
            <a:off x="7792413" y="854468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F7AFD92-1A26-2D4F-BAC5-F8CFF99C973B}"/>
              </a:ext>
            </a:extLst>
          </p:cNvPr>
          <p:cNvCxnSpPr>
            <a:cxnSpLocks/>
          </p:cNvCxnSpPr>
          <p:nvPr/>
        </p:nvCxnSpPr>
        <p:spPr>
          <a:xfrm>
            <a:off x="1849120" y="483600"/>
            <a:ext cx="299883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A52C39A-18FF-E8F8-58E7-568542917E89}"/>
              </a:ext>
            </a:extLst>
          </p:cNvPr>
          <p:cNvSpPr txBox="1"/>
          <p:nvPr/>
        </p:nvSpPr>
        <p:spPr>
          <a:xfrm>
            <a:off x="2919837" y="57134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DA231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8960A64-9E7D-5A79-56E8-6809A56461FB}"/>
              </a:ext>
            </a:extLst>
          </p:cNvPr>
          <p:cNvCxnSpPr>
            <a:cxnSpLocks/>
          </p:cNvCxnSpPr>
          <p:nvPr/>
        </p:nvCxnSpPr>
        <p:spPr>
          <a:xfrm>
            <a:off x="5572299" y="426466"/>
            <a:ext cx="299883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95B02A22-933E-D18D-C8B7-3CA5A7648F98}"/>
              </a:ext>
            </a:extLst>
          </p:cNvPr>
          <p:cNvSpPr txBox="1"/>
          <p:nvPr/>
        </p:nvSpPr>
        <p:spPr>
          <a:xfrm>
            <a:off x="6643016" y="0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L120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9238BF2-B50F-8A96-EBD0-575A82F787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3224" y="5354773"/>
            <a:ext cx="8058150" cy="16097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BC7BCDB-F89F-D1DB-6A11-EAF927C904E2}"/>
              </a:ext>
            </a:extLst>
          </p:cNvPr>
          <p:cNvSpPr txBox="1"/>
          <p:nvPr/>
        </p:nvSpPr>
        <p:spPr>
          <a:xfrm>
            <a:off x="9032122" y="5442356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972427-BA57-FFB8-59F8-8142280D9D2A}"/>
              </a:ext>
            </a:extLst>
          </p:cNvPr>
          <p:cNvSpPr txBox="1"/>
          <p:nvPr/>
        </p:nvSpPr>
        <p:spPr>
          <a:xfrm>
            <a:off x="9032122" y="5673182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FB9C15D-0613-A2BF-764D-B018C893C91D}"/>
              </a:ext>
            </a:extLst>
          </p:cNvPr>
          <p:cNvSpPr txBox="1"/>
          <p:nvPr/>
        </p:nvSpPr>
        <p:spPr>
          <a:xfrm>
            <a:off x="9032122" y="6062082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C5B6B36C-B4AF-330A-0452-F450D9ABC3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95187" y="5416062"/>
            <a:ext cx="523875" cy="114300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23FA4C72-7A8D-A3A1-41FC-AA7753491844}"/>
              </a:ext>
            </a:extLst>
          </p:cNvPr>
          <p:cNvSpPr txBox="1"/>
          <p:nvPr/>
        </p:nvSpPr>
        <p:spPr>
          <a:xfrm>
            <a:off x="613609" y="1743326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899848F-4E6D-5149-045D-7CD2B221C503}"/>
              </a:ext>
            </a:extLst>
          </p:cNvPr>
          <p:cNvSpPr txBox="1"/>
          <p:nvPr/>
        </p:nvSpPr>
        <p:spPr>
          <a:xfrm>
            <a:off x="613609" y="5703813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C43BDDD-94DE-92A2-918B-2065270C45B4}"/>
              </a:ext>
            </a:extLst>
          </p:cNvPr>
          <p:cNvSpPr/>
          <p:nvPr/>
        </p:nvSpPr>
        <p:spPr>
          <a:xfrm>
            <a:off x="3946626" y="2324761"/>
            <a:ext cx="1004644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E91F592-BB4D-4622-0C95-F4CA22339E7F}"/>
              </a:ext>
            </a:extLst>
          </p:cNvPr>
          <p:cNvSpPr/>
          <p:nvPr/>
        </p:nvSpPr>
        <p:spPr>
          <a:xfrm>
            <a:off x="3956785" y="5648709"/>
            <a:ext cx="1109513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57349A34-2165-692B-2301-07CF746E2F06}"/>
              </a:ext>
            </a:extLst>
          </p:cNvPr>
          <p:cNvSpPr/>
          <p:nvPr/>
        </p:nvSpPr>
        <p:spPr>
          <a:xfrm>
            <a:off x="7738316" y="2212501"/>
            <a:ext cx="1004644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ADA26B99-D636-10F9-1CE7-78F1619BD164}"/>
              </a:ext>
            </a:extLst>
          </p:cNvPr>
          <p:cNvSpPr/>
          <p:nvPr/>
        </p:nvSpPr>
        <p:spPr>
          <a:xfrm>
            <a:off x="7859346" y="5618056"/>
            <a:ext cx="1004644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13342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D57FD91-E606-3899-7FED-4CE7AA40D3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8110" y="980457"/>
            <a:ext cx="8477250" cy="43815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E593738-1F37-637D-FD72-742C5ECEA10B}"/>
              </a:ext>
            </a:extLst>
          </p:cNvPr>
          <p:cNvSpPr txBox="1"/>
          <p:nvPr/>
        </p:nvSpPr>
        <p:spPr>
          <a:xfrm>
            <a:off x="9149200" y="1535357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05FFDC-E3DA-4B98-8449-60CE3CD10BEE}"/>
              </a:ext>
            </a:extLst>
          </p:cNvPr>
          <p:cNvSpPr txBox="1"/>
          <p:nvPr/>
        </p:nvSpPr>
        <p:spPr>
          <a:xfrm>
            <a:off x="9149200" y="199227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C99AE6-B447-C576-5DDB-ECDEB2982084}"/>
              </a:ext>
            </a:extLst>
          </p:cNvPr>
          <p:cNvSpPr txBox="1"/>
          <p:nvPr/>
        </p:nvSpPr>
        <p:spPr>
          <a:xfrm>
            <a:off x="9149200" y="257375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39BA74-F694-3FAC-B838-70F46B775606}"/>
              </a:ext>
            </a:extLst>
          </p:cNvPr>
          <p:cNvSpPr txBox="1"/>
          <p:nvPr/>
        </p:nvSpPr>
        <p:spPr>
          <a:xfrm>
            <a:off x="9149199" y="301704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060396-99A5-1180-022A-3905FE728683}"/>
              </a:ext>
            </a:extLst>
          </p:cNvPr>
          <p:cNvSpPr txBox="1"/>
          <p:nvPr/>
        </p:nvSpPr>
        <p:spPr>
          <a:xfrm>
            <a:off x="9149199" y="371683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D17AA5-36DF-3412-7F1B-04394051AFAA}"/>
              </a:ext>
            </a:extLst>
          </p:cNvPr>
          <p:cNvSpPr txBox="1"/>
          <p:nvPr/>
        </p:nvSpPr>
        <p:spPr>
          <a:xfrm>
            <a:off x="9149198" y="453571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D49D82-7EF9-47B7-ABCA-ABFE34594AB4}"/>
              </a:ext>
            </a:extLst>
          </p:cNvPr>
          <p:cNvSpPr txBox="1"/>
          <p:nvPr/>
        </p:nvSpPr>
        <p:spPr>
          <a:xfrm>
            <a:off x="8161057" y="90179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B33889D-7AD6-0767-6635-45DEBFF5E2B1}"/>
              </a:ext>
            </a:extLst>
          </p:cNvPr>
          <p:cNvSpPr txBox="1"/>
          <p:nvPr/>
        </p:nvSpPr>
        <p:spPr>
          <a:xfrm>
            <a:off x="6559294" y="90179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415DF8C-E9A6-5C99-AD8E-3D6DD471D8EB}"/>
              </a:ext>
            </a:extLst>
          </p:cNvPr>
          <p:cNvSpPr txBox="1"/>
          <p:nvPr/>
        </p:nvSpPr>
        <p:spPr>
          <a:xfrm>
            <a:off x="7644863" y="90179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7492B1-257E-6B68-493C-E3DC1F93D20A}"/>
              </a:ext>
            </a:extLst>
          </p:cNvPr>
          <p:cNvSpPr txBox="1"/>
          <p:nvPr/>
        </p:nvSpPr>
        <p:spPr>
          <a:xfrm>
            <a:off x="7165256" y="90179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D905A8-FD24-2ECE-F2DC-E9E3773CC032}"/>
              </a:ext>
            </a:extLst>
          </p:cNvPr>
          <p:cNvSpPr txBox="1"/>
          <p:nvPr/>
        </p:nvSpPr>
        <p:spPr>
          <a:xfrm>
            <a:off x="5473725" y="90179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224D152-568C-CFC6-B644-24ACA04429D2}"/>
              </a:ext>
            </a:extLst>
          </p:cNvPr>
          <p:cNvSpPr txBox="1"/>
          <p:nvPr/>
        </p:nvSpPr>
        <p:spPr>
          <a:xfrm>
            <a:off x="6079687" y="90179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C311E4-C9F2-0D4E-BFD1-7DF0C4C4C345}"/>
              </a:ext>
            </a:extLst>
          </p:cNvPr>
          <p:cNvSpPr txBox="1"/>
          <p:nvPr/>
        </p:nvSpPr>
        <p:spPr>
          <a:xfrm>
            <a:off x="3929422" y="90179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A41F3C-B527-63FF-732D-0C314C2347E9}"/>
              </a:ext>
            </a:extLst>
          </p:cNvPr>
          <p:cNvSpPr txBox="1"/>
          <p:nvPr/>
        </p:nvSpPr>
        <p:spPr>
          <a:xfrm>
            <a:off x="4535384" y="90179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4E9BBE-597C-74C2-C399-3096F56051DC}"/>
              </a:ext>
            </a:extLst>
          </p:cNvPr>
          <p:cNvSpPr txBox="1"/>
          <p:nvPr/>
        </p:nvSpPr>
        <p:spPr>
          <a:xfrm>
            <a:off x="2809749" y="867394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CC2AC6-3F73-7E42-942A-6D3BDDE6526B}"/>
              </a:ext>
            </a:extLst>
          </p:cNvPr>
          <p:cNvSpPr txBox="1"/>
          <p:nvPr/>
        </p:nvSpPr>
        <p:spPr>
          <a:xfrm>
            <a:off x="3415711" y="86739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486D19F-05A6-7544-9449-7C05D32E7C15}"/>
              </a:ext>
            </a:extLst>
          </p:cNvPr>
          <p:cNvSpPr txBox="1"/>
          <p:nvPr/>
        </p:nvSpPr>
        <p:spPr>
          <a:xfrm>
            <a:off x="1746111" y="867394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7117649-BE49-8591-9260-86EA556E4507}"/>
              </a:ext>
            </a:extLst>
          </p:cNvPr>
          <p:cNvSpPr txBox="1"/>
          <p:nvPr/>
        </p:nvSpPr>
        <p:spPr>
          <a:xfrm>
            <a:off x="2352073" y="86739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FEF37DF-3896-012F-71B4-9BC71C019F42}"/>
              </a:ext>
            </a:extLst>
          </p:cNvPr>
          <p:cNvSpPr txBox="1"/>
          <p:nvPr/>
        </p:nvSpPr>
        <p:spPr>
          <a:xfrm>
            <a:off x="2056452" y="36931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C81EDDA-9AF0-8ABE-5879-A15F6A09AC57}"/>
              </a:ext>
            </a:extLst>
          </p:cNvPr>
          <p:cNvSpPr txBox="1"/>
          <p:nvPr/>
        </p:nvSpPr>
        <p:spPr>
          <a:xfrm>
            <a:off x="1189548" y="274067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8FD0432-3040-8696-BD67-1D8528751A89}"/>
              </a:ext>
            </a:extLst>
          </p:cNvPr>
          <p:cNvCxnSpPr/>
          <p:nvPr/>
        </p:nvCxnSpPr>
        <p:spPr>
          <a:xfrm>
            <a:off x="1828800" y="738645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3D38347-8CD2-62C0-2923-2567C0A1156D}"/>
              </a:ext>
            </a:extLst>
          </p:cNvPr>
          <p:cNvSpPr txBox="1"/>
          <p:nvPr/>
        </p:nvSpPr>
        <p:spPr>
          <a:xfrm>
            <a:off x="3043709" y="36931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5AC9354-24FF-9A91-0E57-5B1F8740D786}"/>
              </a:ext>
            </a:extLst>
          </p:cNvPr>
          <p:cNvCxnSpPr/>
          <p:nvPr/>
        </p:nvCxnSpPr>
        <p:spPr>
          <a:xfrm>
            <a:off x="2816057" y="738645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34E435E-C616-3705-C6C5-26D1895D0F28}"/>
              </a:ext>
            </a:extLst>
          </p:cNvPr>
          <p:cNvSpPr txBox="1"/>
          <p:nvPr/>
        </p:nvSpPr>
        <p:spPr>
          <a:xfrm>
            <a:off x="4266736" y="37668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1A0B9E8-A075-4443-594E-DA0EB0BB1747}"/>
              </a:ext>
            </a:extLst>
          </p:cNvPr>
          <p:cNvCxnSpPr/>
          <p:nvPr/>
        </p:nvCxnSpPr>
        <p:spPr>
          <a:xfrm>
            <a:off x="4039084" y="746015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C00859E6-E215-2B8A-C92F-5929E9D102FC}"/>
              </a:ext>
            </a:extLst>
          </p:cNvPr>
          <p:cNvSpPr txBox="1"/>
          <p:nvPr/>
        </p:nvSpPr>
        <p:spPr>
          <a:xfrm>
            <a:off x="5800104" y="35886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C4DB8EAD-93B3-32C8-17D5-538AD1324CF6}"/>
              </a:ext>
            </a:extLst>
          </p:cNvPr>
          <p:cNvCxnSpPr/>
          <p:nvPr/>
        </p:nvCxnSpPr>
        <p:spPr>
          <a:xfrm>
            <a:off x="5572452" y="728198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A31DA9A9-BE39-F495-577A-2720F031D8BD}"/>
              </a:ext>
            </a:extLst>
          </p:cNvPr>
          <p:cNvSpPr txBox="1"/>
          <p:nvPr/>
        </p:nvSpPr>
        <p:spPr>
          <a:xfrm>
            <a:off x="6892326" y="34351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6D97AD7-6E18-2861-78AF-2992CD7D57B7}"/>
              </a:ext>
            </a:extLst>
          </p:cNvPr>
          <p:cNvCxnSpPr/>
          <p:nvPr/>
        </p:nvCxnSpPr>
        <p:spPr>
          <a:xfrm>
            <a:off x="6664674" y="712842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98E8EFFC-FC81-7755-1888-82B0A342974A}"/>
              </a:ext>
            </a:extLst>
          </p:cNvPr>
          <p:cNvSpPr txBox="1"/>
          <p:nvPr/>
        </p:nvSpPr>
        <p:spPr>
          <a:xfrm>
            <a:off x="7999745" y="34289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FF04BBF-CA1C-0902-0205-9D98C48F2FF1}"/>
              </a:ext>
            </a:extLst>
          </p:cNvPr>
          <p:cNvCxnSpPr/>
          <p:nvPr/>
        </p:nvCxnSpPr>
        <p:spPr>
          <a:xfrm>
            <a:off x="7772093" y="712228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F7AFD92-1A26-2D4F-BAC5-F8CFF99C973B}"/>
              </a:ext>
            </a:extLst>
          </p:cNvPr>
          <p:cNvCxnSpPr>
            <a:cxnSpLocks/>
          </p:cNvCxnSpPr>
          <p:nvPr/>
        </p:nvCxnSpPr>
        <p:spPr>
          <a:xfrm>
            <a:off x="1828800" y="341360"/>
            <a:ext cx="299883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A52C39A-18FF-E8F8-58E7-568542917E89}"/>
              </a:ext>
            </a:extLst>
          </p:cNvPr>
          <p:cNvSpPr txBox="1"/>
          <p:nvPr/>
        </p:nvSpPr>
        <p:spPr>
          <a:xfrm>
            <a:off x="2899517" y="-85106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8960A64-9E7D-5A79-56E8-6809A56461FB}"/>
              </a:ext>
            </a:extLst>
          </p:cNvPr>
          <p:cNvCxnSpPr>
            <a:cxnSpLocks/>
          </p:cNvCxnSpPr>
          <p:nvPr/>
        </p:nvCxnSpPr>
        <p:spPr>
          <a:xfrm>
            <a:off x="5551979" y="284226"/>
            <a:ext cx="299883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95B02A22-933E-D18D-C8B7-3CA5A7648F98}"/>
              </a:ext>
            </a:extLst>
          </p:cNvPr>
          <p:cNvSpPr txBox="1"/>
          <p:nvPr/>
        </p:nvSpPr>
        <p:spPr>
          <a:xfrm>
            <a:off x="6622696" y="-14224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ED8BCB8A-29BE-6D05-0A97-A1DAD03225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5990" y="5060851"/>
            <a:ext cx="8201025" cy="179070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F5A025B5-A6E2-0C93-A694-AA3F930E4227}"/>
              </a:ext>
            </a:extLst>
          </p:cNvPr>
          <p:cNvSpPr txBox="1"/>
          <p:nvPr/>
        </p:nvSpPr>
        <p:spPr>
          <a:xfrm>
            <a:off x="498668" y="1992272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BFA3265-FDA1-45E7-0F78-E5121DF3BBAC}"/>
              </a:ext>
            </a:extLst>
          </p:cNvPr>
          <p:cNvSpPr txBox="1"/>
          <p:nvPr/>
        </p:nvSpPr>
        <p:spPr>
          <a:xfrm>
            <a:off x="598553" y="5593596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CF476820-866B-9D65-194B-81B688E29C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51815" y="5549269"/>
            <a:ext cx="685800" cy="962025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7198F273-D353-2036-30D3-2FE033785113}"/>
              </a:ext>
            </a:extLst>
          </p:cNvPr>
          <p:cNvSpPr txBox="1"/>
          <p:nvPr/>
        </p:nvSpPr>
        <p:spPr>
          <a:xfrm>
            <a:off x="9296282" y="5523636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4DB94FA-90C5-1211-0F6B-DCC3AE1FE0CB}"/>
              </a:ext>
            </a:extLst>
          </p:cNvPr>
          <p:cNvSpPr txBox="1"/>
          <p:nvPr/>
        </p:nvSpPr>
        <p:spPr>
          <a:xfrm>
            <a:off x="9296282" y="5754462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C63F5F1-337D-04AD-A467-D0B1DFBF77AF}"/>
              </a:ext>
            </a:extLst>
          </p:cNvPr>
          <p:cNvSpPr txBox="1"/>
          <p:nvPr/>
        </p:nvSpPr>
        <p:spPr>
          <a:xfrm>
            <a:off x="9296282" y="6143362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DF8C2ACD-4DEB-2766-6DBA-DA392FDF0B17}"/>
              </a:ext>
            </a:extLst>
          </p:cNvPr>
          <p:cNvSpPr/>
          <p:nvPr/>
        </p:nvSpPr>
        <p:spPr>
          <a:xfrm>
            <a:off x="7643983" y="2098931"/>
            <a:ext cx="1004644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1D8399F2-3AA2-7278-673A-A425655C4B37}"/>
              </a:ext>
            </a:extLst>
          </p:cNvPr>
          <p:cNvSpPr/>
          <p:nvPr/>
        </p:nvSpPr>
        <p:spPr>
          <a:xfrm>
            <a:off x="7614473" y="5603756"/>
            <a:ext cx="1004644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16A508C-1980-94E0-2AD7-B19D062D07CC}"/>
              </a:ext>
            </a:extLst>
          </p:cNvPr>
          <p:cNvSpPr/>
          <p:nvPr/>
        </p:nvSpPr>
        <p:spPr>
          <a:xfrm>
            <a:off x="1722129" y="2043789"/>
            <a:ext cx="1120657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95F7547B-FC0D-1EE8-2355-70E909980D0C}"/>
              </a:ext>
            </a:extLst>
          </p:cNvPr>
          <p:cNvSpPr/>
          <p:nvPr/>
        </p:nvSpPr>
        <p:spPr>
          <a:xfrm>
            <a:off x="1694805" y="5639078"/>
            <a:ext cx="1004644" cy="3693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8522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E5A8D48-850F-DCF3-0D44-1A19D667CF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40868" y="2186305"/>
            <a:ext cx="4655486" cy="33102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6B20EAA-1159-480E-D67D-26919B88CFDF}"/>
              </a:ext>
            </a:extLst>
          </p:cNvPr>
          <p:cNvSpPr txBox="1"/>
          <p:nvPr/>
        </p:nvSpPr>
        <p:spPr>
          <a:xfrm>
            <a:off x="11247002" y="2902356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804C2F3-5904-BE3D-370C-E895A05B70B1}"/>
              </a:ext>
            </a:extLst>
          </p:cNvPr>
          <p:cNvSpPr txBox="1"/>
          <p:nvPr/>
        </p:nvSpPr>
        <p:spPr>
          <a:xfrm>
            <a:off x="11247002" y="3308534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F7321E-7C9E-A950-9483-D1C1774ED515}"/>
              </a:ext>
            </a:extLst>
          </p:cNvPr>
          <p:cNvSpPr txBox="1"/>
          <p:nvPr/>
        </p:nvSpPr>
        <p:spPr>
          <a:xfrm>
            <a:off x="11148124" y="4084045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11BEF2-390B-F8F1-A8B7-B5D8694680C4}"/>
              </a:ext>
            </a:extLst>
          </p:cNvPr>
          <p:cNvSpPr txBox="1"/>
          <p:nvPr/>
        </p:nvSpPr>
        <p:spPr>
          <a:xfrm>
            <a:off x="5986761" y="2902356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21610A3-59F5-7EC2-0779-14D8BBDE01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4393" y="1680622"/>
            <a:ext cx="3665085" cy="416731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DCCBB141-76A5-09A3-C30B-F79AACA2D310}"/>
              </a:ext>
            </a:extLst>
          </p:cNvPr>
          <p:cNvSpPr txBox="1"/>
          <p:nvPr/>
        </p:nvSpPr>
        <p:spPr>
          <a:xfrm>
            <a:off x="4283410" y="215225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42A36FB-E48A-5379-91F0-40919283184B}"/>
              </a:ext>
            </a:extLst>
          </p:cNvPr>
          <p:cNvSpPr txBox="1"/>
          <p:nvPr/>
        </p:nvSpPr>
        <p:spPr>
          <a:xfrm>
            <a:off x="4283410" y="260916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765DB6-E711-C3FD-439B-9F02AC84081F}"/>
              </a:ext>
            </a:extLst>
          </p:cNvPr>
          <p:cNvSpPr txBox="1"/>
          <p:nvPr/>
        </p:nvSpPr>
        <p:spPr>
          <a:xfrm>
            <a:off x="4158020" y="327448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CB16678-21CD-47B8-D8B6-E29FD800FCD7}"/>
              </a:ext>
            </a:extLst>
          </p:cNvPr>
          <p:cNvSpPr txBox="1"/>
          <p:nvPr/>
        </p:nvSpPr>
        <p:spPr>
          <a:xfrm>
            <a:off x="4161105" y="3877725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A53C0D3-F340-F124-7421-C82626263D26}"/>
              </a:ext>
            </a:extLst>
          </p:cNvPr>
          <p:cNvSpPr txBox="1"/>
          <p:nvPr/>
        </p:nvSpPr>
        <p:spPr>
          <a:xfrm>
            <a:off x="3915596" y="478196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6CEA271-211A-FBBC-C403-D22C7B9E4C9F}"/>
              </a:ext>
            </a:extLst>
          </p:cNvPr>
          <p:cNvSpPr txBox="1"/>
          <p:nvPr/>
        </p:nvSpPr>
        <p:spPr>
          <a:xfrm>
            <a:off x="392414" y="2703472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66DC50A-6166-6790-F36B-02519ED6EA31}"/>
              </a:ext>
            </a:extLst>
          </p:cNvPr>
          <p:cNvSpPr txBox="1"/>
          <p:nvPr/>
        </p:nvSpPr>
        <p:spPr>
          <a:xfrm>
            <a:off x="962640" y="1495956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D4CCA16-C0FC-560E-1D48-F1F7D4539665}"/>
              </a:ext>
            </a:extLst>
          </p:cNvPr>
          <p:cNvSpPr txBox="1"/>
          <p:nvPr/>
        </p:nvSpPr>
        <p:spPr>
          <a:xfrm>
            <a:off x="1568602" y="1495956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34C479E-C5B9-DE2D-EA7F-17064610C8A3}"/>
              </a:ext>
            </a:extLst>
          </p:cNvPr>
          <p:cNvSpPr txBox="1"/>
          <p:nvPr/>
        </p:nvSpPr>
        <p:spPr>
          <a:xfrm>
            <a:off x="1289019" y="95302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5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BBEAAAC-4F3E-E06B-F387-736300412EDD}"/>
              </a:ext>
            </a:extLst>
          </p:cNvPr>
          <p:cNvCxnSpPr/>
          <p:nvPr/>
        </p:nvCxnSpPr>
        <p:spPr>
          <a:xfrm>
            <a:off x="1061367" y="1322355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F99C9772-6DB7-9454-60EB-8EB3B549C665}"/>
              </a:ext>
            </a:extLst>
          </p:cNvPr>
          <p:cNvSpPr txBox="1"/>
          <p:nvPr/>
        </p:nvSpPr>
        <p:spPr>
          <a:xfrm>
            <a:off x="2777596" y="139963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BF6C62D-BFE3-0C87-B203-A942B568F6E9}"/>
              </a:ext>
            </a:extLst>
          </p:cNvPr>
          <p:cNvSpPr txBox="1"/>
          <p:nvPr/>
        </p:nvSpPr>
        <p:spPr>
          <a:xfrm>
            <a:off x="3383558" y="139963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3B7D0AC-0918-2C2A-7027-9967C92C1F0B}"/>
              </a:ext>
            </a:extLst>
          </p:cNvPr>
          <p:cNvSpPr txBox="1"/>
          <p:nvPr/>
        </p:nvSpPr>
        <p:spPr>
          <a:xfrm>
            <a:off x="3103975" y="85670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4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4EE4873-F4D3-028D-E004-E9129DC8C1EF}"/>
              </a:ext>
            </a:extLst>
          </p:cNvPr>
          <p:cNvCxnSpPr/>
          <p:nvPr/>
        </p:nvCxnSpPr>
        <p:spPr>
          <a:xfrm>
            <a:off x="2876323" y="1226038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4346CA3D-B59D-97C2-10E5-9D51DF44D237}"/>
              </a:ext>
            </a:extLst>
          </p:cNvPr>
          <p:cNvSpPr txBox="1"/>
          <p:nvPr/>
        </p:nvSpPr>
        <p:spPr>
          <a:xfrm>
            <a:off x="9558045" y="2364271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7F24DA7-B7C2-11A8-3637-3ECD14E39D30}"/>
              </a:ext>
            </a:extLst>
          </p:cNvPr>
          <p:cNvSpPr txBox="1"/>
          <p:nvPr/>
        </p:nvSpPr>
        <p:spPr>
          <a:xfrm>
            <a:off x="10164007" y="2364271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9DEDCAF-A8FD-B9BA-CB91-B5AB91D1693F}"/>
              </a:ext>
            </a:extLst>
          </p:cNvPr>
          <p:cNvSpPr txBox="1"/>
          <p:nvPr/>
        </p:nvSpPr>
        <p:spPr>
          <a:xfrm>
            <a:off x="9884424" y="1821338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4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662223D-AAC2-DA75-0A33-B1481021CB36}"/>
              </a:ext>
            </a:extLst>
          </p:cNvPr>
          <p:cNvCxnSpPr/>
          <p:nvPr/>
        </p:nvCxnSpPr>
        <p:spPr>
          <a:xfrm>
            <a:off x="9656772" y="2190670"/>
            <a:ext cx="90456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D030F005-0B63-E14A-1801-9DF3613657E8}"/>
              </a:ext>
            </a:extLst>
          </p:cNvPr>
          <p:cNvSpPr txBox="1"/>
          <p:nvPr/>
        </p:nvSpPr>
        <p:spPr>
          <a:xfrm>
            <a:off x="6998340" y="2370971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8D17E30-6BB9-D3EE-9092-FA08E3E1F100}"/>
              </a:ext>
            </a:extLst>
          </p:cNvPr>
          <p:cNvSpPr txBox="1"/>
          <p:nvPr/>
        </p:nvSpPr>
        <p:spPr>
          <a:xfrm>
            <a:off x="8856656" y="234835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B8C626C-C7A6-E59C-1EB9-492406AF7E3C}"/>
              </a:ext>
            </a:extLst>
          </p:cNvPr>
          <p:cNvSpPr txBox="1"/>
          <p:nvPr/>
        </p:nvSpPr>
        <p:spPr>
          <a:xfrm>
            <a:off x="7324719" y="199009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5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6409E7B-771A-739D-A9EA-231FC4500826}"/>
              </a:ext>
            </a:extLst>
          </p:cNvPr>
          <p:cNvCxnSpPr>
            <a:cxnSpLocks/>
            <a:endCxn id="38" idx="0"/>
          </p:cNvCxnSpPr>
          <p:nvPr/>
        </p:nvCxnSpPr>
        <p:spPr>
          <a:xfrm flipV="1">
            <a:off x="7097067" y="2348358"/>
            <a:ext cx="202504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8FA06F63-362C-4008-E3F4-D2215E2D296C}"/>
              </a:ext>
            </a:extLst>
          </p:cNvPr>
          <p:cNvSpPr txBox="1"/>
          <p:nvPr/>
        </p:nvSpPr>
        <p:spPr>
          <a:xfrm>
            <a:off x="564646" y="299505"/>
            <a:ext cx="795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T549</a:t>
            </a:r>
          </a:p>
        </p:txBody>
      </p:sp>
    </p:spTree>
    <p:extLst>
      <p:ext uri="{BB962C8B-B14F-4D97-AF65-F5344CB8AC3E}">
        <p14:creationId xmlns:p14="http://schemas.microsoft.com/office/powerpoint/2010/main" val="4272116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163</Words>
  <Application>Microsoft Office PowerPoint</Application>
  <PresentationFormat>Widescreen</PresentationFormat>
  <Paragraphs>10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7</cp:revision>
  <dcterms:created xsi:type="dcterms:W3CDTF">2024-06-19T15:40:59Z</dcterms:created>
  <dcterms:modified xsi:type="dcterms:W3CDTF">2024-07-08T17:13:01Z</dcterms:modified>
</cp:coreProperties>
</file>